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490" autoAdjust="0"/>
    <p:restoredTop sz="94660"/>
  </p:normalViewPr>
  <p:slideViewPr>
    <p:cSldViewPr snapToGrid="0">
      <p:cViewPr varScale="1">
        <p:scale>
          <a:sx n="53" d="100"/>
          <a:sy n="53" d="100"/>
        </p:scale>
        <p:origin x="-2192" y="-12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97156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5061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2746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3173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54523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3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11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735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093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5420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24219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748F0-74FA-4F22-BC39-069594AC31B3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E82870-9E3B-4C96-A890-FD83F0FD3E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9887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76882068"/>
              </p:ext>
            </p:extLst>
          </p:nvPr>
        </p:nvGraphicFramePr>
        <p:xfrm>
          <a:off x="106680" y="3608212"/>
          <a:ext cx="6625870" cy="2650348"/>
        </p:xfrm>
        <a:graphic>
          <a:graphicData uri="http://schemas.openxmlformats.org/drawingml/2006/table">
            <a:tbl>
              <a:tblPr firstRow="1" firstCol="1" bandRow="1"/>
              <a:tblGrid>
                <a:gridCol w="2145405"/>
                <a:gridCol w="2247835"/>
                <a:gridCol w="2232630"/>
              </a:tblGrid>
              <a:tr h="345698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w-Intensity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derate-Intensity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High-Intensity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460930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aily dose lowers LDL-C by </a:t>
                      </a: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lt;30%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aily dose lowers LDL-C by </a:t>
                      </a: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0-50%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aily dose lowers LDL-C by </a:t>
                      </a: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&gt;50%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CCCCC"/>
                    </a:solidFill>
                  </a:tcPr>
                </a:tc>
              </a:tr>
              <a:tr h="1843720"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vastatin 20-4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vastatin 2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itavastatin 1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avastatin 10-2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mvastatin 1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orvastatin 10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20)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vastatin 40mg, BID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luvastatin XL 8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ovastatin 4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itavastatin 2-4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avastatin 40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80)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imvastatin 20-4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suvastatin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5)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torvastatin 40-80mg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Rosuvastatin 20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40)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g</a:t>
                      </a:r>
                      <a:r>
                        <a:rPr lang="en-US" sz="15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5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86424" marR="8642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375204" y="8617652"/>
            <a:ext cx="6003635" cy="2862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dditional File 4.pptx: High- Moderate- and Low-Intensity Statin Therapy. Statin dosages that achieve plasma reductions in LDL-C of &lt;30% (Low-Intensity), between 30-50% (Moderate-Intensity), and &gt;50% (High-Intensity), as tested in randomized control trials (RCTs) and reported in the 2013 American College of Cardiology (ACC) and American Heart Association (AHA) 2013 guidelines</a:t>
            </a:r>
            <a:r>
              <a:rPr lang="en-US" baseline="30000" dirty="0"/>
              <a:t>37</a:t>
            </a:r>
            <a:r>
              <a:rPr lang="en-US" dirty="0"/>
              <a:t>. Statin dosages reported in </a:t>
            </a:r>
            <a:r>
              <a:rPr lang="en-US" i="1" dirty="0"/>
              <a:t>italics</a:t>
            </a:r>
            <a:r>
              <a:rPr lang="en-US" dirty="0"/>
              <a:t> are FDA approved but have not been tested in RCTs. BID = twice daily; XL = extended release</a:t>
            </a:r>
            <a:r>
              <a:rPr lang="en-US" dirty="0"/>
              <a:t> </a:t>
            </a:r>
            <a:endParaRPr lang="en-US" dirty="0" smtClean="0"/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1243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12</Words>
  <Application>Microsoft Macintosh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Beckwitt</dc:creator>
  <cp:lastModifiedBy>Alan Wells</cp:lastModifiedBy>
  <cp:revision>11</cp:revision>
  <dcterms:created xsi:type="dcterms:W3CDTF">2018-05-04T13:31:49Z</dcterms:created>
  <dcterms:modified xsi:type="dcterms:W3CDTF">2018-05-24T18:30:17Z</dcterms:modified>
</cp:coreProperties>
</file>